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443741-242E-4133-A7D0-7BF580A30F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B1DB2E-900D-42D2-B931-6E5269B62C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801DEC-8CC8-4A87-B15D-A7A4E995D0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108A66-BEDD-4777-8368-CFC5702524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B0163D-776D-486A-A454-A554EC124D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9005E0-94D0-466E-8145-03EF5C9C54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2282B-B294-4A6E-912C-3E4898FF7D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7A63D4-E2A6-4075-B421-4BB2A03A9F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184796-FC26-49FC-B2EF-713A06079D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6F324-550B-4555-8558-E1F1702F25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41E8D7-1302-498A-BEB6-6BCE04A015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B1362E-106B-45B5-A3CD-65BC98986C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1984696-0DA3-4970-A118-F5B5F55A602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2"/>
          <p:cNvSpPr/>
          <p:nvPr/>
        </p:nvSpPr>
        <p:spPr>
          <a:xfrm>
            <a:off x="0" y="4495680"/>
            <a:ext cx="685800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able S2. Splenic lymphocyte subsets in naïve WT, UbE1L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-/-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n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SG15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neonatal mi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% total cell population, mean ± sem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52280" y="1371600"/>
          <a:ext cx="6553440" cy="2362320"/>
        </p:xfrm>
        <a:graphic>
          <a:graphicData uri="http://schemas.openxmlformats.org/drawingml/2006/table">
            <a:tbl>
              <a:tblPr/>
              <a:tblGrid>
                <a:gridCol w="2787840"/>
                <a:gridCol w="1279440"/>
                <a:gridCol w="1355760"/>
                <a:gridCol w="1130400"/>
              </a:tblGrid>
              <a:tr h="3380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Cell Typ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W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ISG15-/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UbE1L-/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3366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 cells (CD19+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10 ± 3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27 ± 2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08 ± 0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</a:tr>
              <a:tr h="3380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K cells (NK1.1+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3 ± 0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5 ± 0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5 ± 0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3366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4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T cells (CD4+CD3+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85 ± 0.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5 ± 0.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2 ± 0.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</a:tr>
              <a:tr h="3384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8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T cells (CD8+CD3+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52 ± 0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1 ± 0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3 ± 0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3362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anulocytes (Gr1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hi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F4/80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low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2 ± 0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8 ± 0.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83 ± 0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</a:tr>
              <a:tr h="3384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nocytes (Gr1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int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F4/80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int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8 ± 0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8 ± 0.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1 ± 0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e7e7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7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5T14:25:27Z</dcterms:created>
  <dc:creator>Clementine</dc:creator>
  <dc:description/>
  <dc:language>en-US</dc:language>
  <cp:lastModifiedBy>Internal Medicine</cp:lastModifiedBy>
  <cp:lastPrinted>2010-09-10T09:16:17Z</cp:lastPrinted>
  <dcterms:modified xsi:type="dcterms:W3CDTF">2011-08-22T16:26:49Z</dcterms:modified>
  <cp:revision>396</cp:revision>
  <dc:subject/>
  <dc:title>PowerPoint Presentation</dc:title>
</cp:coreProperties>
</file>